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57" r:id="rId2"/>
    <p:sldId id="293" r:id="rId3"/>
    <p:sldId id="295" r:id="rId4"/>
    <p:sldId id="297" r:id="rId5"/>
    <p:sldId id="296" r:id="rId6"/>
    <p:sldId id="299" r:id="rId7"/>
    <p:sldId id="298" r:id="rId8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보통 스타일 2 - 강조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80" d="100"/>
          <a:sy n="80" d="100"/>
        </p:scale>
        <p:origin x="238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5" d="100"/>
        <a:sy n="10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8FEF7-CC14-4670-A29D-B4A92373DDB4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1188C3-0EC0-40A8-B58C-AF15C6CCFE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1481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24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4634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5378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783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518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263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8885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0745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0604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0022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4751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7F653-C59C-4318-9DD7-D7D811A718D6}" type="datetimeFigureOut">
              <a:rPr lang="ko-KR" altLang="en-US" smtClean="0"/>
              <a:t>2023-04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B8D2E-6188-45FD-B7B8-7ADF2E81EC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7973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Box 90"/>
          <p:cNvSpPr txBox="1"/>
          <p:nvPr/>
        </p:nvSpPr>
        <p:spPr>
          <a:xfrm>
            <a:off x="2529700" y="389291"/>
            <a:ext cx="22401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1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1148312" y="1275626"/>
            <a:ext cx="4638877" cy="6962876"/>
            <a:chOff x="1148312" y="1275626"/>
            <a:chExt cx="4638877" cy="6962876"/>
          </a:xfrm>
        </p:grpSpPr>
        <p:sp>
          <p:nvSpPr>
            <p:cNvPr id="69" name="TextBox 68"/>
            <p:cNvSpPr txBox="1"/>
            <p:nvPr/>
          </p:nvSpPr>
          <p:spPr>
            <a:xfrm>
              <a:off x="2655225" y="1275626"/>
              <a:ext cx="15755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1C original da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직사각형 6"/>
            <p:cNvSpPr/>
            <p:nvPr/>
          </p:nvSpPr>
          <p:spPr>
            <a:xfrm>
              <a:off x="1148312" y="1588977"/>
              <a:ext cx="4638877" cy="66495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3635" b="32096"/>
            <a:stretch/>
          </p:blipFill>
          <p:spPr>
            <a:xfrm>
              <a:off x="1235891" y="1652259"/>
              <a:ext cx="4551298" cy="6586243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1733564" y="1720951"/>
              <a:ext cx="51527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EGFR</a:t>
              </a:r>
              <a:endParaRPr lang="ko-KR" altLang="en-US" sz="105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475969" y="2807394"/>
              <a:ext cx="103046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EGFR</a:t>
              </a:r>
              <a:endParaRPr lang="ko-KR" altLang="en-US" sz="105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89774" y="3809012"/>
              <a:ext cx="5590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MAPK</a:t>
              </a:r>
              <a:endParaRPr lang="ko-KR" altLang="en-US" sz="105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415973" y="4945380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MAPK</a:t>
              </a:r>
              <a:endParaRPr lang="ko-KR" altLang="en-US" sz="105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711668" y="5991364"/>
              <a:ext cx="5590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AKT</a:t>
              </a:r>
              <a:endParaRPr lang="ko-KR" altLang="en-US" sz="105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451823" y="6929440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AKT</a:t>
              </a:r>
              <a:endParaRPr lang="ko-KR" altLang="en-US" sz="105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314701" y="1741175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</a:t>
              </a:r>
              <a:endParaRPr lang="ko-KR" altLang="en-US" sz="105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314701" y="3227075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53</a:t>
              </a:r>
              <a:endParaRPr lang="ko-KR" altLang="en-US" sz="105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200401" y="4275463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Tubulin</a:t>
              </a:r>
              <a:endParaRPr lang="ko-KR" altLang="en-US" sz="105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7373961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541419" y="489864"/>
            <a:ext cx="5847347" cy="8942887"/>
            <a:chOff x="541419" y="489864"/>
            <a:chExt cx="5847347" cy="8942887"/>
          </a:xfrm>
        </p:grpSpPr>
        <p:sp>
          <p:nvSpPr>
            <p:cNvPr id="446" name="TextBox 445"/>
            <p:cNvSpPr txBox="1"/>
            <p:nvPr/>
          </p:nvSpPr>
          <p:spPr>
            <a:xfrm>
              <a:off x="2550518" y="489864"/>
              <a:ext cx="1901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2D original da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7" name="직사각형 446"/>
            <p:cNvSpPr/>
            <p:nvPr/>
          </p:nvSpPr>
          <p:spPr>
            <a:xfrm>
              <a:off x="541419" y="803215"/>
              <a:ext cx="5847347" cy="862953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1404" b="2449"/>
            <a:stretch/>
          </p:blipFill>
          <p:spPr>
            <a:xfrm>
              <a:off x="715330" y="831124"/>
              <a:ext cx="5523588" cy="8601627"/>
            </a:xfrm>
            <a:prstGeom prst="rect">
              <a:avLst/>
            </a:prstGeom>
          </p:spPr>
        </p:pic>
        <p:sp>
          <p:nvSpPr>
            <p:cNvPr id="30" name="직사각형 29"/>
            <p:cNvSpPr/>
            <p:nvPr/>
          </p:nvSpPr>
          <p:spPr>
            <a:xfrm>
              <a:off x="1804737" y="2461602"/>
              <a:ext cx="1243997" cy="380597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1" name="직사각형 30"/>
            <p:cNvSpPr/>
            <p:nvPr/>
          </p:nvSpPr>
          <p:spPr>
            <a:xfrm>
              <a:off x="1756608" y="8593697"/>
              <a:ext cx="1243997" cy="380597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2" name="직사각형 31"/>
            <p:cNvSpPr/>
            <p:nvPr/>
          </p:nvSpPr>
          <p:spPr>
            <a:xfrm>
              <a:off x="4439655" y="1370738"/>
              <a:ext cx="1480613" cy="380597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3" name="직사각형 32"/>
            <p:cNvSpPr/>
            <p:nvPr/>
          </p:nvSpPr>
          <p:spPr>
            <a:xfrm>
              <a:off x="3539342" y="7571955"/>
              <a:ext cx="1011278" cy="314543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3849791" y="2389409"/>
              <a:ext cx="1011278" cy="582391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321786" y="838749"/>
              <a:ext cx="51527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EGFR</a:t>
              </a:r>
              <a:endParaRPr lang="ko-KR" altLang="en-US" sz="105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484413" y="1885712"/>
              <a:ext cx="103046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 smtClean="0"/>
                <a:t>phospho</a:t>
              </a:r>
              <a:r>
                <a:rPr lang="en-US" altLang="ko-KR" sz="1050" b="1" dirty="0" smtClean="0"/>
                <a:t>-EGFR</a:t>
              </a:r>
              <a:endParaRPr lang="ko-KR" altLang="en-US" sz="105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321786" y="3230848"/>
              <a:ext cx="5590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MAPK</a:t>
              </a:r>
              <a:endParaRPr lang="ko-KR" altLang="en-US" sz="105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019793" y="4199711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MAPK</a:t>
              </a:r>
              <a:endParaRPr lang="ko-KR" altLang="en-US" sz="105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340835" y="5269846"/>
              <a:ext cx="5590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AKT</a:t>
              </a:r>
              <a:endParaRPr lang="ko-KR" altLang="en-US" sz="105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175082" y="6143215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AKT</a:t>
              </a:r>
              <a:endParaRPr lang="ko-KR" altLang="en-US" sz="105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269105" y="7159095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</a:t>
              </a:r>
              <a:endParaRPr lang="ko-KR" altLang="en-US" sz="105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861803" y="8008282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53</a:t>
              </a:r>
              <a:endParaRPr lang="ko-KR" altLang="en-US" sz="105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101518" y="8116190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Tubulin</a:t>
              </a:r>
              <a:endParaRPr lang="ko-KR" altLang="en-US" sz="105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950618" y="7059772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Ku70</a:t>
              </a:r>
              <a:endParaRPr lang="ko-KR" altLang="en-US" sz="105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40160" y="6120062"/>
              <a:ext cx="145094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765001" y="5142888"/>
              <a:ext cx="138802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625885" y="4101262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/>
                <a:t>p</a:t>
              </a:r>
              <a:r>
                <a:rPr lang="en-US" altLang="ko-KR" sz="1050" b="1" dirty="0" smtClean="0"/>
                <a:t>hospho-H2A.X</a:t>
              </a:r>
              <a:endParaRPr lang="ko-KR" altLang="en-US" sz="105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001931" y="3141004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27</a:t>
              </a:r>
              <a:endParaRPr lang="ko-KR" altLang="en-US" sz="105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004010" y="1986006"/>
              <a:ext cx="9320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aspase3</a:t>
              </a:r>
              <a:endParaRPr lang="ko-KR" altLang="en-US" sz="105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525090" y="814017"/>
              <a:ext cx="9320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ARP</a:t>
              </a:r>
              <a:endParaRPr lang="ko-KR" altLang="en-US" sz="105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6195407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541419" y="489864"/>
            <a:ext cx="5847347" cy="7198315"/>
            <a:chOff x="541419" y="489864"/>
            <a:chExt cx="5847347" cy="7198315"/>
          </a:xfrm>
        </p:grpSpPr>
        <p:sp>
          <p:nvSpPr>
            <p:cNvPr id="3" name="TextBox 2"/>
            <p:cNvSpPr txBox="1"/>
            <p:nvPr/>
          </p:nvSpPr>
          <p:spPr>
            <a:xfrm>
              <a:off x="2550518" y="489864"/>
              <a:ext cx="1901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4D original da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직사각형 3"/>
            <p:cNvSpPr/>
            <p:nvPr/>
          </p:nvSpPr>
          <p:spPr>
            <a:xfrm>
              <a:off x="541419" y="803215"/>
              <a:ext cx="5847347" cy="688496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158" b="25646"/>
            <a:stretch/>
          </p:blipFill>
          <p:spPr>
            <a:xfrm>
              <a:off x="757986" y="962586"/>
              <a:ext cx="5414211" cy="6556259"/>
            </a:xfrm>
            <a:prstGeom prst="rect">
              <a:avLst/>
            </a:prstGeom>
          </p:spPr>
        </p:pic>
        <p:sp>
          <p:nvSpPr>
            <p:cNvPr id="25" name="직사각형 24"/>
            <p:cNvSpPr/>
            <p:nvPr/>
          </p:nvSpPr>
          <p:spPr>
            <a:xfrm>
              <a:off x="1239253" y="6882063"/>
              <a:ext cx="1949115" cy="259420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857366" y="946196"/>
              <a:ext cx="51527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EGFR</a:t>
              </a:r>
              <a:endParaRPr lang="ko-KR" altLang="en-US" sz="105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22376" y="1781116"/>
              <a:ext cx="103046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EGFR</a:t>
              </a:r>
              <a:endParaRPr lang="ko-KR" altLang="en-US" sz="105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854520" y="2850814"/>
              <a:ext cx="5590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MAPK</a:t>
              </a:r>
              <a:endParaRPr lang="ko-KR" altLang="en-US" sz="105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603455" y="3867142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MAPK</a:t>
              </a:r>
              <a:endParaRPr lang="ko-KR" altLang="en-US" sz="105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542105" y="6083491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Tubulin</a:t>
              </a:r>
              <a:endParaRPr lang="ko-KR" altLang="en-US" sz="105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490792" y="4104232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Ku70</a:t>
              </a:r>
              <a:endParaRPr lang="ko-KR" altLang="en-US" sz="105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245010" y="3104730"/>
              <a:ext cx="145094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451687" y="2131256"/>
              <a:ext cx="138802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254535" y="953061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/>
                <a:t>p</a:t>
              </a:r>
              <a:r>
                <a:rPr lang="en-US" altLang="ko-KR" sz="1050" b="1" dirty="0" smtClean="0"/>
                <a:t>hospho-H2A.X</a:t>
              </a:r>
              <a:endParaRPr lang="ko-KR" altLang="en-US" sz="105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593418" y="5038821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27</a:t>
              </a:r>
              <a:endParaRPr lang="ko-KR" altLang="en-US" sz="105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610104" y="6009286"/>
              <a:ext cx="12854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leaved Caspase3</a:t>
              </a:r>
              <a:endParaRPr lang="ko-KR" altLang="en-US" sz="105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650951" y="4917790"/>
              <a:ext cx="113306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leaved RARP</a:t>
              </a:r>
              <a:endParaRPr lang="ko-KR" altLang="en-US" sz="105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2427572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974558" y="489864"/>
            <a:ext cx="4896844" cy="8683170"/>
            <a:chOff x="974558" y="489864"/>
            <a:chExt cx="4896844" cy="8683170"/>
          </a:xfrm>
        </p:grpSpPr>
        <p:sp>
          <p:nvSpPr>
            <p:cNvPr id="2" name="TextBox 1"/>
            <p:cNvSpPr txBox="1"/>
            <p:nvPr/>
          </p:nvSpPr>
          <p:spPr>
            <a:xfrm>
              <a:off x="2550518" y="489864"/>
              <a:ext cx="1901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5A original da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직사각형 2"/>
            <p:cNvSpPr/>
            <p:nvPr/>
          </p:nvSpPr>
          <p:spPr>
            <a:xfrm>
              <a:off x="974558" y="854242"/>
              <a:ext cx="4896844" cy="831879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16" name="그림 15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3158" b="14730"/>
            <a:stretch/>
          </p:blipFill>
          <p:spPr>
            <a:xfrm>
              <a:off x="1209086" y="902370"/>
              <a:ext cx="4584032" cy="8270664"/>
            </a:xfrm>
            <a:prstGeom prst="rect">
              <a:avLst/>
            </a:prstGeom>
          </p:spPr>
        </p:pic>
        <p:sp>
          <p:nvSpPr>
            <p:cNvPr id="28" name="직사각형 27"/>
            <p:cNvSpPr/>
            <p:nvPr/>
          </p:nvSpPr>
          <p:spPr>
            <a:xfrm>
              <a:off x="1636297" y="5341159"/>
              <a:ext cx="1106903" cy="380597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" name="직사각형 28"/>
            <p:cNvSpPr/>
            <p:nvPr/>
          </p:nvSpPr>
          <p:spPr>
            <a:xfrm>
              <a:off x="3549316" y="2846610"/>
              <a:ext cx="1106903" cy="380597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" name="직사각형 29"/>
            <p:cNvSpPr/>
            <p:nvPr/>
          </p:nvSpPr>
          <p:spPr>
            <a:xfrm>
              <a:off x="3581398" y="1789087"/>
              <a:ext cx="1106903" cy="345997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861340" y="902370"/>
              <a:ext cx="51527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EGFR</a:t>
              </a:r>
              <a:endParaRPr lang="ko-KR" altLang="en-US" sz="105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600874" y="1881168"/>
              <a:ext cx="103046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EGFR</a:t>
              </a:r>
              <a:endParaRPr lang="ko-KR" altLang="en-US" sz="105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825412" y="2846610"/>
              <a:ext cx="5590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MAPK</a:t>
              </a:r>
              <a:endParaRPr lang="ko-KR" altLang="en-US" sz="105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589172" y="3942160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MAPK</a:t>
              </a:r>
              <a:endParaRPr lang="ko-KR" altLang="en-US" sz="105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25412" y="4936221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</a:t>
              </a:r>
              <a:endParaRPr lang="ko-KR" altLang="en-US" sz="105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957820" y="5930282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53</a:t>
              </a:r>
              <a:endParaRPr lang="ko-KR" altLang="en-US" sz="105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920497" y="7863602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Tubulin</a:t>
              </a:r>
              <a:endParaRPr lang="ko-KR" altLang="en-US" sz="105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971810" y="6639107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 smtClean="0"/>
                <a:t>Bax</a:t>
              </a:r>
              <a:endParaRPr lang="ko-KR" altLang="en-US" sz="105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501102" y="4467083"/>
              <a:ext cx="145094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669285" y="3441070"/>
              <a:ext cx="138802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83615" y="2208356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/>
                <a:t>p</a:t>
              </a:r>
              <a:r>
                <a:rPr lang="en-US" altLang="ko-KR" sz="1050" b="1" dirty="0" smtClean="0"/>
                <a:t>hospho-H2A.X</a:t>
              </a:r>
              <a:endParaRPr lang="ko-KR" altLang="en-US" sz="105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971810" y="5540277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27</a:t>
              </a:r>
              <a:endParaRPr lang="ko-KR" altLang="en-US" sz="105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756282" y="930945"/>
              <a:ext cx="9320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aspase3</a:t>
              </a:r>
              <a:endParaRPr lang="ko-KR" altLang="en-US" sz="105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780229" y="8117518"/>
              <a:ext cx="114154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leaved RARP</a:t>
              </a:r>
              <a:endParaRPr lang="ko-KR" altLang="en-US" sz="105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910607" y="7163518"/>
              <a:ext cx="9320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ARP</a:t>
              </a:r>
              <a:endParaRPr lang="ko-KR" altLang="en-US" sz="105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1988201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445169" y="489864"/>
            <a:ext cx="5943598" cy="8461631"/>
            <a:chOff x="445169" y="489864"/>
            <a:chExt cx="5943598" cy="8461631"/>
          </a:xfrm>
        </p:grpSpPr>
        <p:sp>
          <p:nvSpPr>
            <p:cNvPr id="3" name="TextBox 2"/>
            <p:cNvSpPr txBox="1"/>
            <p:nvPr/>
          </p:nvSpPr>
          <p:spPr>
            <a:xfrm>
              <a:off x="2550518" y="489864"/>
              <a:ext cx="1901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5E original da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직사각형 3"/>
            <p:cNvSpPr/>
            <p:nvPr/>
          </p:nvSpPr>
          <p:spPr>
            <a:xfrm>
              <a:off x="445169" y="803215"/>
              <a:ext cx="5943598" cy="81482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1930" b="9892"/>
            <a:stretch/>
          </p:blipFill>
          <p:spPr>
            <a:xfrm>
              <a:off x="671580" y="921689"/>
              <a:ext cx="5490775" cy="7945360"/>
            </a:xfrm>
            <a:prstGeom prst="rect">
              <a:avLst/>
            </a:prstGeom>
          </p:spPr>
        </p:pic>
        <p:sp>
          <p:nvSpPr>
            <p:cNvPr id="28" name="직사각형 27"/>
            <p:cNvSpPr/>
            <p:nvPr/>
          </p:nvSpPr>
          <p:spPr>
            <a:xfrm>
              <a:off x="1106906" y="5575187"/>
              <a:ext cx="1876926" cy="380597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" name="직사각형 28"/>
            <p:cNvSpPr/>
            <p:nvPr/>
          </p:nvSpPr>
          <p:spPr>
            <a:xfrm>
              <a:off x="1263321" y="7922602"/>
              <a:ext cx="1876926" cy="345997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" name="직사각형 29"/>
            <p:cNvSpPr/>
            <p:nvPr/>
          </p:nvSpPr>
          <p:spPr>
            <a:xfrm>
              <a:off x="4002513" y="7880433"/>
              <a:ext cx="1876926" cy="285948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32368" y="938631"/>
              <a:ext cx="51527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EGFR</a:t>
              </a:r>
              <a:endParaRPr lang="ko-KR" altLang="en-US" sz="105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518175" y="1937801"/>
              <a:ext cx="103046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EGFR</a:t>
              </a:r>
              <a:endParaRPr lang="ko-KR" altLang="en-US" sz="105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753875" y="3048149"/>
              <a:ext cx="5590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MAPK</a:t>
              </a:r>
              <a:endParaRPr lang="ko-KR" altLang="en-US" sz="105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518175" y="4090747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MAPK</a:t>
              </a:r>
              <a:endParaRPr lang="ko-KR" altLang="en-US" sz="105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720244" y="5168629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</a:t>
              </a:r>
              <a:endParaRPr lang="ko-KR" altLang="en-US" sz="105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296964" y="7402037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Tubulin</a:t>
              </a:r>
              <a:endParaRPr lang="ko-KR" altLang="en-US" sz="105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360673" y="6245484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 smtClean="0"/>
                <a:t>Bax</a:t>
              </a:r>
              <a:endParaRPr lang="ko-KR" altLang="en-US" sz="105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04593" y="3131327"/>
              <a:ext cx="145094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246964" y="1998084"/>
              <a:ext cx="138802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123643" y="938631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/>
                <a:t>p</a:t>
              </a:r>
              <a:r>
                <a:rPr lang="en-US" altLang="ko-KR" sz="1050" b="1" dirty="0" smtClean="0"/>
                <a:t>hospho-H2A.X</a:t>
              </a:r>
              <a:endParaRPr lang="ko-KR" altLang="en-US" sz="105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348277" y="5121004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27</a:t>
              </a:r>
              <a:endParaRPr lang="ko-KR" altLang="en-US" sz="105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520219" y="7066531"/>
              <a:ext cx="126358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leaved Caspase3</a:t>
              </a:r>
              <a:endParaRPr lang="ko-KR" altLang="en-US" sz="105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77779" y="6128051"/>
              <a:ext cx="114154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leaved RARP</a:t>
              </a:r>
              <a:endParaRPr lang="ko-KR" altLang="en-US" sz="105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351670" y="4101400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Ku70</a:t>
              </a:r>
              <a:endParaRPr lang="ko-KR" altLang="en-US" sz="105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1413853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/>
          <p:cNvGrpSpPr/>
          <p:nvPr/>
        </p:nvGrpSpPr>
        <p:grpSpPr>
          <a:xfrm>
            <a:off x="192504" y="489864"/>
            <a:ext cx="6521117" cy="9231652"/>
            <a:chOff x="192504" y="489864"/>
            <a:chExt cx="6521117" cy="9231652"/>
          </a:xfrm>
        </p:grpSpPr>
        <p:sp>
          <p:nvSpPr>
            <p:cNvPr id="2" name="TextBox 1"/>
            <p:cNvSpPr txBox="1"/>
            <p:nvPr/>
          </p:nvSpPr>
          <p:spPr>
            <a:xfrm>
              <a:off x="2550518" y="489864"/>
              <a:ext cx="1901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5F original da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직사각형 2"/>
            <p:cNvSpPr/>
            <p:nvPr/>
          </p:nvSpPr>
          <p:spPr>
            <a:xfrm>
              <a:off x="192504" y="846159"/>
              <a:ext cx="6521117" cy="88753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0" r="1367" b="1209"/>
            <a:stretch/>
          </p:blipFill>
          <p:spPr>
            <a:xfrm>
              <a:off x="383830" y="950494"/>
              <a:ext cx="6149318" cy="8630734"/>
            </a:xfrm>
            <a:prstGeom prst="rect">
              <a:avLst/>
            </a:prstGeom>
          </p:spPr>
        </p:pic>
        <p:sp>
          <p:nvSpPr>
            <p:cNvPr id="50" name="직사각형 49"/>
            <p:cNvSpPr/>
            <p:nvPr/>
          </p:nvSpPr>
          <p:spPr>
            <a:xfrm>
              <a:off x="866203" y="9212869"/>
              <a:ext cx="389891" cy="259953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5" name="직사각형 54"/>
            <p:cNvSpPr/>
            <p:nvPr/>
          </p:nvSpPr>
          <p:spPr>
            <a:xfrm>
              <a:off x="1872846" y="9160731"/>
              <a:ext cx="389891" cy="259953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6" name="직사각형 55"/>
            <p:cNvSpPr/>
            <p:nvPr/>
          </p:nvSpPr>
          <p:spPr>
            <a:xfrm>
              <a:off x="3003810" y="9172765"/>
              <a:ext cx="389891" cy="259953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7" name="직사각형 56"/>
            <p:cNvSpPr/>
            <p:nvPr/>
          </p:nvSpPr>
          <p:spPr>
            <a:xfrm>
              <a:off x="4904803" y="2422834"/>
              <a:ext cx="389891" cy="236321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8" name="직사각형 57"/>
            <p:cNvSpPr/>
            <p:nvPr/>
          </p:nvSpPr>
          <p:spPr>
            <a:xfrm>
              <a:off x="4912822" y="2647426"/>
              <a:ext cx="389891" cy="236321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9" name="직사각형 58"/>
            <p:cNvSpPr/>
            <p:nvPr/>
          </p:nvSpPr>
          <p:spPr>
            <a:xfrm>
              <a:off x="4896777" y="2908113"/>
              <a:ext cx="389891" cy="236321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0" name="직사각형 59"/>
            <p:cNvSpPr/>
            <p:nvPr/>
          </p:nvSpPr>
          <p:spPr>
            <a:xfrm>
              <a:off x="3771567" y="4621063"/>
              <a:ext cx="322224" cy="195306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1" name="직사각형 60"/>
            <p:cNvSpPr/>
            <p:nvPr/>
          </p:nvSpPr>
          <p:spPr>
            <a:xfrm>
              <a:off x="4730086" y="4677210"/>
              <a:ext cx="322224" cy="195306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2" name="직사각형 61"/>
            <p:cNvSpPr/>
            <p:nvPr/>
          </p:nvSpPr>
          <p:spPr>
            <a:xfrm>
              <a:off x="5652502" y="4709292"/>
              <a:ext cx="322224" cy="195306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164395" y="882255"/>
              <a:ext cx="176321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 IP/phosph-H2A.X IB</a:t>
              </a:r>
              <a:endParaRPr lang="ko-KR" altLang="en-US" sz="105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69304" y="1654626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746166" y="2012416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649549" y="2012416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061148" y="2184529"/>
              <a:ext cx="165439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 IP/PARP IB</a:t>
              </a:r>
              <a:endParaRPr lang="ko-KR" altLang="en-US" sz="1050" b="1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79196" y="3052819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608432" y="3070299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386284" y="3079824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218806" y="3280997"/>
              <a:ext cx="165439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 IP/Ku70 IB</a:t>
              </a:r>
              <a:endParaRPr lang="ko-KR" altLang="en-US" sz="105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44770" y="4024591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574006" y="4042071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351858" y="4051596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218806" y="4166142"/>
              <a:ext cx="165439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 IP/DNA-</a:t>
              </a:r>
              <a:r>
                <a:rPr lang="en-US" altLang="ko-KR" sz="1050" b="1" dirty="0" err="1" smtClean="0"/>
                <a:t>PKcs</a:t>
              </a:r>
              <a:r>
                <a:rPr lang="en-US" altLang="ko-KR" sz="1050" b="1" dirty="0" smtClean="0"/>
                <a:t> IB</a:t>
              </a:r>
              <a:endParaRPr lang="ko-KR" altLang="en-US" sz="1050" b="1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44770" y="4900211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678781" y="4917691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428058" y="4927216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266431" y="5043122"/>
              <a:ext cx="165439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 IP/RUNX3 IB</a:t>
              </a:r>
              <a:endParaRPr lang="ko-KR" altLang="en-US" sz="1050" b="1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68570" y="5920066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707356" y="5956596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656658" y="5975646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7" name="직선 화살표 연결선 6"/>
            <p:cNvCxnSpPr/>
            <p:nvPr/>
          </p:nvCxnSpPr>
          <p:spPr>
            <a:xfrm>
              <a:off x="491297" y="1088546"/>
              <a:ext cx="2807079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직선 화살표 연결선 52"/>
            <p:cNvCxnSpPr/>
            <p:nvPr/>
          </p:nvCxnSpPr>
          <p:spPr>
            <a:xfrm>
              <a:off x="608369" y="2381295"/>
              <a:ext cx="2319900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직선 화살표 연결선 53"/>
            <p:cNvCxnSpPr/>
            <p:nvPr/>
          </p:nvCxnSpPr>
          <p:spPr>
            <a:xfrm>
              <a:off x="636944" y="3476670"/>
              <a:ext cx="2319900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직선 화살표 연결선 62"/>
            <p:cNvCxnSpPr/>
            <p:nvPr/>
          </p:nvCxnSpPr>
          <p:spPr>
            <a:xfrm>
              <a:off x="684569" y="4372020"/>
              <a:ext cx="2319900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직선 화살표 연결선 63"/>
            <p:cNvCxnSpPr/>
            <p:nvPr/>
          </p:nvCxnSpPr>
          <p:spPr>
            <a:xfrm>
              <a:off x="479080" y="5238795"/>
              <a:ext cx="2807079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1700577" y="6071745"/>
              <a:ext cx="5342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ARP</a:t>
              </a:r>
              <a:endParaRPr lang="ko-KR" altLang="en-US" sz="1050" b="1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840766" y="7034414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779552" y="7051894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2728854" y="7070944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70" name="직선 화살표 연결선 69"/>
            <p:cNvCxnSpPr/>
            <p:nvPr/>
          </p:nvCxnSpPr>
          <p:spPr>
            <a:xfrm>
              <a:off x="551276" y="6267418"/>
              <a:ext cx="2807079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1510077" y="7179647"/>
              <a:ext cx="102827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leaved PARP</a:t>
              </a:r>
              <a:endParaRPr lang="ko-KR" altLang="en-US" sz="1050" b="1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840766" y="8008966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779552" y="7978821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786004" y="7988346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75" name="직선 화살표 연결선 74"/>
            <p:cNvCxnSpPr/>
            <p:nvPr/>
          </p:nvCxnSpPr>
          <p:spPr>
            <a:xfrm>
              <a:off x="551276" y="7375320"/>
              <a:ext cx="2807079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6" name="TextBox 75"/>
            <p:cNvSpPr txBox="1"/>
            <p:nvPr/>
          </p:nvSpPr>
          <p:spPr>
            <a:xfrm>
              <a:off x="1447644" y="8130725"/>
              <a:ext cx="125410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leaved Caspase 3</a:t>
              </a:r>
              <a:endParaRPr lang="ko-KR" altLang="en-US" sz="1050" b="1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841497" y="9441311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888569" y="9459286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895021" y="9456788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80" name="직선 화살표 연결선 79"/>
            <p:cNvCxnSpPr/>
            <p:nvPr/>
          </p:nvCxnSpPr>
          <p:spPr>
            <a:xfrm>
              <a:off x="660293" y="8326398"/>
              <a:ext cx="2807079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1" name="TextBox 80"/>
            <p:cNvSpPr txBox="1"/>
            <p:nvPr/>
          </p:nvSpPr>
          <p:spPr>
            <a:xfrm>
              <a:off x="4450075" y="989704"/>
              <a:ext cx="133859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hospho-H2A.X</a:t>
              </a:r>
              <a:endParaRPr lang="ko-KR" altLang="en-US" sz="1050" b="1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780764" y="1867151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719550" y="1873102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5726002" y="1906691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85" name="직선 화살표 연결선 84"/>
            <p:cNvCxnSpPr/>
            <p:nvPr/>
          </p:nvCxnSpPr>
          <p:spPr>
            <a:xfrm>
              <a:off x="3491274" y="1185377"/>
              <a:ext cx="2807079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4664135" y="2118378"/>
              <a:ext cx="62477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Ku70</a:t>
              </a:r>
              <a:endParaRPr lang="ko-KR" altLang="en-US" sz="1050" b="1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310732" y="2416594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5294694" y="2664437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5288005" y="2937403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450582" y="3222912"/>
              <a:ext cx="133859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709079" y="4004103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4972721" y="4010054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5582125" y="4043643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94" name="직선 화살표 연결선 93"/>
            <p:cNvCxnSpPr/>
            <p:nvPr/>
          </p:nvCxnSpPr>
          <p:spPr>
            <a:xfrm>
              <a:off x="3351427" y="3442649"/>
              <a:ext cx="3087787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>
              <a:off x="4233622" y="4123984"/>
              <a:ext cx="133859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 smtClean="0"/>
                <a:t>phospho</a:t>
              </a:r>
              <a:r>
                <a:rPr lang="en-US" altLang="ko-KR" sz="1050" b="1" dirty="0" smtClean="0"/>
                <a:t>-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3684631" y="5145815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4623417" y="5151766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5629869" y="5185355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99" name="직선 화살표 연결선 98"/>
            <p:cNvCxnSpPr/>
            <p:nvPr/>
          </p:nvCxnSpPr>
          <p:spPr>
            <a:xfrm>
              <a:off x="3522735" y="4343721"/>
              <a:ext cx="2551890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4638223" y="5288343"/>
              <a:ext cx="133859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27</a:t>
              </a:r>
              <a:endParaRPr lang="ko-KR" altLang="en-US" sz="1050" b="1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728278" y="6189854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4618936" y="6231901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5613356" y="6265490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104" name="직선 화살표 연결선 103"/>
            <p:cNvCxnSpPr/>
            <p:nvPr/>
          </p:nvCxnSpPr>
          <p:spPr>
            <a:xfrm>
              <a:off x="3590446" y="5508080"/>
              <a:ext cx="2551890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5" name="TextBox 104"/>
            <p:cNvSpPr txBox="1"/>
            <p:nvPr/>
          </p:nvSpPr>
          <p:spPr>
            <a:xfrm>
              <a:off x="4605293" y="6369364"/>
              <a:ext cx="133859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 smtClean="0"/>
                <a:t>Bax</a:t>
              </a:r>
              <a:endParaRPr lang="ko-KR" altLang="en-US" sz="1050" b="1" dirty="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910253" y="7167615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4669427" y="7179647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5452975" y="7179647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109" name="직선 화살표 연결선 108"/>
            <p:cNvCxnSpPr/>
            <p:nvPr/>
          </p:nvCxnSpPr>
          <p:spPr>
            <a:xfrm>
              <a:off x="3778961" y="6589101"/>
              <a:ext cx="2109000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>
              <a:off x="4804535" y="7289838"/>
              <a:ext cx="133859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Tubulin</a:t>
              </a:r>
              <a:endParaRPr lang="ko-KR" altLang="en-US" sz="1050" b="1" dirty="0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4073399" y="8124185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520</a:t>
              </a:r>
              <a:endParaRPr lang="ko-KR" altLang="en-US" sz="900" b="1" dirty="0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4928826" y="8136217"/>
              <a:ext cx="486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1975</a:t>
              </a:r>
              <a:endParaRPr lang="ko-KR" altLang="en-US" sz="900" b="1" dirty="0"/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5796597" y="8136217"/>
              <a:ext cx="651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/>
                <a:t>HCC827</a:t>
              </a:r>
              <a:endParaRPr lang="ko-KR" altLang="en-US" sz="900" b="1" dirty="0"/>
            </a:p>
          </p:txBody>
        </p:sp>
        <p:cxnSp>
          <p:nvCxnSpPr>
            <p:cNvPr id="114" name="직선 화살표 연결선 113"/>
            <p:cNvCxnSpPr/>
            <p:nvPr/>
          </p:nvCxnSpPr>
          <p:spPr>
            <a:xfrm>
              <a:off x="3804886" y="7509575"/>
              <a:ext cx="2551890" cy="0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728711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529389" y="489864"/>
            <a:ext cx="5810071" cy="7571294"/>
            <a:chOff x="529389" y="489864"/>
            <a:chExt cx="5810071" cy="7571294"/>
          </a:xfrm>
        </p:grpSpPr>
        <p:sp>
          <p:nvSpPr>
            <p:cNvPr id="4" name="TextBox 3"/>
            <p:cNvSpPr txBox="1"/>
            <p:nvPr/>
          </p:nvSpPr>
          <p:spPr>
            <a:xfrm>
              <a:off x="2550518" y="489864"/>
              <a:ext cx="1901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6B original da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529389" y="803215"/>
              <a:ext cx="5810071" cy="72579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6" name="그림 5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947" b="20808"/>
            <a:stretch/>
          </p:blipFill>
          <p:spPr>
            <a:xfrm>
              <a:off x="602583" y="886626"/>
              <a:ext cx="5676717" cy="6982834"/>
            </a:xfrm>
            <a:prstGeom prst="rect">
              <a:avLst/>
            </a:prstGeom>
          </p:spPr>
        </p:pic>
        <p:sp>
          <p:nvSpPr>
            <p:cNvPr id="24" name="직사각형 23"/>
            <p:cNvSpPr/>
            <p:nvPr/>
          </p:nvSpPr>
          <p:spPr>
            <a:xfrm>
              <a:off x="1106906" y="5262366"/>
              <a:ext cx="1443612" cy="380597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" name="직사각형 24"/>
            <p:cNvSpPr/>
            <p:nvPr/>
          </p:nvSpPr>
          <p:spPr>
            <a:xfrm>
              <a:off x="3410360" y="2274689"/>
              <a:ext cx="1443612" cy="259953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6" name="직사각형 25"/>
            <p:cNvSpPr/>
            <p:nvPr/>
          </p:nvSpPr>
          <p:spPr>
            <a:xfrm>
              <a:off x="3406347" y="3148767"/>
              <a:ext cx="1443612" cy="236321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7" name="직사각형 26"/>
            <p:cNvSpPr/>
            <p:nvPr/>
          </p:nvSpPr>
          <p:spPr>
            <a:xfrm>
              <a:off x="1145239" y="7307683"/>
              <a:ext cx="1443612" cy="236321"/>
            </a:xfrm>
            <a:prstGeom prst="rect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316893" y="1905830"/>
              <a:ext cx="103046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EGFR</a:t>
              </a:r>
              <a:endParaRPr lang="ko-KR" altLang="en-US" sz="105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96346" y="2801530"/>
              <a:ext cx="5590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MAPK</a:t>
              </a:r>
              <a:endParaRPr lang="ko-KR" altLang="en-US" sz="105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266469" y="3786668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MAPK</a:t>
              </a:r>
              <a:endParaRPr lang="ko-KR" altLang="en-US" sz="105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496346" y="4820737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RUNX3</a:t>
              </a:r>
              <a:endParaRPr lang="ko-KR" altLang="en-US" sz="105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754016" y="6645864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Tubulin</a:t>
              </a:r>
              <a:endParaRPr lang="ko-KR" altLang="en-US" sz="105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832765" y="5549603"/>
              <a:ext cx="6953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 smtClean="0"/>
                <a:t>Bax</a:t>
              </a:r>
              <a:endParaRPr lang="ko-KR" altLang="en-US" sz="105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368264" y="2714830"/>
              <a:ext cx="145094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err="1"/>
                <a:t>p</a:t>
              </a:r>
              <a:r>
                <a:rPr lang="en-US" altLang="ko-KR" sz="1050" b="1" dirty="0" err="1" smtClean="0"/>
                <a:t>hospho</a:t>
              </a:r>
              <a:r>
                <a:rPr lang="en-US" altLang="ko-KR" sz="1050" b="1" dirty="0" smtClean="0"/>
                <a:t>-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501102" y="935239"/>
              <a:ext cx="12011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/>
                <a:t>p</a:t>
              </a:r>
              <a:r>
                <a:rPr lang="en-US" altLang="ko-KR" sz="1050" b="1" dirty="0" smtClean="0"/>
                <a:t>hospho-H2A.X</a:t>
              </a:r>
              <a:endParaRPr lang="ko-KR" altLang="en-US" sz="105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832765" y="4669992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p27</a:t>
              </a:r>
              <a:endParaRPr lang="ko-KR" altLang="en-US" sz="105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153610" y="6885104"/>
              <a:ext cx="126358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leaved Caspase3</a:t>
              </a:r>
              <a:endParaRPr lang="ko-KR" altLang="en-US" sz="105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304569" y="5905410"/>
              <a:ext cx="114154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Cleaved RARP</a:t>
              </a:r>
              <a:endParaRPr lang="ko-KR" altLang="en-US" sz="105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761422" y="3668789"/>
              <a:ext cx="5926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Ku70</a:t>
              </a:r>
              <a:endParaRPr lang="ko-KR" altLang="en-US" sz="105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40179" y="908412"/>
              <a:ext cx="103046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EGFR</a:t>
              </a:r>
              <a:endParaRPr lang="ko-KR" altLang="en-US" sz="105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667721" y="1956033"/>
              <a:ext cx="145094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/>
                <a:t>DNA-</a:t>
              </a:r>
              <a:r>
                <a:rPr lang="en-US" altLang="ko-KR" sz="1050" b="1" dirty="0" err="1" smtClean="0"/>
                <a:t>PKcs</a:t>
              </a:r>
              <a:endParaRPr lang="ko-KR" altLang="en-US" sz="105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06247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77</TotalTime>
  <Words>192</Words>
  <Application>Microsoft Office PowerPoint</Application>
  <PresentationFormat>A4 용지(210x297mm)</PresentationFormat>
  <Paragraphs>148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519</cp:revision>
  <cp:lastPrinted>2022-08-29T06:59:02Z</cp:lastPrinted>
  <dcterms:created xsi:type="dcterms:W3CDTF">2022-01-17T02:17:16Z</dcterms:created>
  <dcterms:modified xsi:type="dcterms:W3CDTF">2023-04-21T04:17:59Z</dcterms:modified>
</cp:coreProperties>
</file>